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70" r:id="rId3"/>
    <p:sldId id="271" r:id="rId4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08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68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3712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6670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5505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3782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24652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56726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3105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38226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0712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78550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DB968-55A7-46FC-ACB7-183C515EF30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2016/6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736F84-ED7D-4093-B293-83B9382A661C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793040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 descr="C:\Users\kenkyuu\Desktop\ESAN1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" y="684367"/>
            <a:ext cx="6630987" cy="28510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6" name="Picture 4" descr="C:\Users\kenkyuu\Desktop\ESAN1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3924453"/>
            <a:ext cx="6630987" cy="28510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7" name="Picture 5" descr="C:\Users\kenkyuu\Desktop\SAND2MC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7040717"/>
            <a:ext cx="6630987" cy="28510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151307" y="518334"/>
            <a:ext cx="797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ESAN1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51308" y="3535455"/>
            <a:ext cx="797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ESAN2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71450" y="6775543"/>
            <a:ext cx="830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SAND1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71453" y="-4886"/>
            <a:ext cx="656991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smtClean="0"/>
              <a:t>Fig </a:t>
            </a:r>
            <a:r>
              <a:rPr lang="en-US" altLang="ja-JP" sz="1400" dirty="0" smtClean="0"/>
              <a:t>S4 Principal </a:t>
            </a:r>
            <a:r>
              <a:rPr lang="en-US" altLang="ja-JP" sz="1400" dirty="0"/>
              <a:t>Component Analysis (PCA) score </a:t>
            </a:r>
            <a:r>
              <a:rPr lang="en-US" altLang="ja-JP" sz="1400" dirty="0" smtClean="0"/>
              <a:t>plot obtained </a:t>
            </a:r>
            <a:r>
              <a:rPr lang="en-US" altLang="ja-JP" sz="1400" dirty="0"/>
              <a:t>from DIYABC analysis </a:t>
            </a:r>
            <a:r>
              <a:rPr lang="en-US" altLang="ja-JP" sz="1400" dirty="0" smtClean="0"/>
              <a:t>for each population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9075127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kenkyuu\Desktop\KANT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81850"/>
            <a:ext cx="6610350" cy="2842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9" name="Picture 3" descr="C:\Users\kenkyuu\Desktop\IZU1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739387"/>
            <a:ext cx="6610350" cy="2842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kenkyuu\Desktop\izu2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849331"/>
            <a:ext cx="6610350" cy="2842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190500" y="181740"/>
            <a:ext cx="6992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KANT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90502" y="3339276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IZU1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90502" y="6530010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IZU2</a:t>
            </a:r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317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kenkyuu\Desktop\SADO2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" y="519379"/>
            <a:ext cx="6567745" cy="28238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0" y="144461"/>
            <a:ext cx="833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SADO1</a:t>
            </a:r>
            <a:endParaRPr lang="ja-JP" altLang="en-US" dirty="0">
              <a:solidFill>
                <a:prstClr val="black"/>
              </a:solidFill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28603" y="3529014"/>
            <a:ext cx="633914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solidFill>
                  <a:prstClr val="black"/>
                </a:solidFill>
              </a:rPr>
              <a:t>Fig. </a:t>
            </a:r>
            <a:r>
              <a:rPr lang="en-US" altLang="ja-JP" smtClean="0">
                <a:solidFill>
                  <a:prstClr val="black"/>
                </a:solidFill>
              </a:rPr>
              <a:t>S4</a:t>
            </a:r>
            <a:endParaRPr lang="en-US" altLang="ja-JP" dirty="0">
              <a:solidFill>
                <a:prstClr val="black"/>
              </a:solidFill>
            </a:endParaRPr>
          </a:p>
          <a:p>
            <a:endParaRPr lang="en-US" altLang="ja-JP" dirty="0">
              <a:solidFill>
                <a:prstClr val="black"/>
              </a:solidFill>
            </a:endParaRPr>
          </a:p>
          <a:p>
            <a:r>
              <a:rPr lang="en-US" altLang="ja-JP" dirty="0">
                <a:solidFill>
                  <a:prstClr val="black"/>
                </a:solidFill>
              </a:rPr>
              <a:t>PCA plot of prior, posterior and observed data </a:t>
            </a:r>
            <a:r>
              <a:rPr lang="en-US" altLang="ja-JP" dirty="0" smtClean="0">
                <a:solidFill>
                  <a:prstClr val="black"/>
                </a:solidFill>
              </a:rPr>
              <a:t>set</a:t>
            </a:r>
            <a:r>
              <a:rPr lang="ja-JP" altLang="en-US" dirty="0">
                <a:solidFill>
                  <a:prstClr val="black"/>
                </a:solidFill>
              </a:rPr>
              <a:t> </a:t>
            </a:r>
            <a:r>
              <a:rPr lang="en-US" altLang="ja-JP" dirty="0">
                <a:solidFill>
                  <a:prstClr val="black"/>
                </a:solidFill>
              </a:rPr>
              <a:t>for summary statistics.</a:t>
            </a:r>
          </a:p>
          <a:p>
            <a:endParaRPr lang="ja-JP" altLang="en-US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642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</TotalTime>
  <Words>41</Words>
  <Application>Microsoft Office PowerPoint</Application>
  <PresentationFormat>A4 210 x 297 mm</PresentationFormat>
  <Paragraphs>11</Paragraphs>
  <Slides>3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4" baseType="lpstr"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indows User</dc:creator>
  <cp:lastModifiedBy>Windows User</cp:lastModifiedBy>
  <cp:revision>22</cp:revision>
  <dcterms:created xsi:type="dcterms:W3CDTF">2016-02-26T00:50:55Z</dcterms:created>
  <dcterms:modified xsi:type="dcterms:W3CDTF">2016-06-07T09:36:07Z</dcterms:modified>
</cp:coreProperties>
</file>